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598" r:id="rId3"/>
    <p:sldId id="599" r:id="rId4"/>
    <p:sldId id="64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843"/>
    <p:restoredTop sz="94626"/>
  </p:normalViewPr>
  <p:slideViewPr>
    <p:cSldViewPr snapToGrid="0">
      <p:cViewPr varScale="1">
        <p:scale>
          <a:sx n="105" d="100"/>
          <a:sy n="105" d="100"/>
        </p:scale>
        <p:origin x="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8B97B-7FE3-EC44-9F58-175ED328EB5F}" type="datetimeFigureOut">
              <a:rPr lang="en-US" smtClean="0"/>
              <a:t>8/7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E5F15-3CF6-3140-ACD5-16F01C93C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434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2A00A6-5CEA-9D4E-88D8-4E7D37664B3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284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2A00A6-5CEA-9D4E-88D8-4E7D37664B3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46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F74D0-4B2A-8AB0-AD5E-430E9A6918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AF85D7-6510-D958-C997-4D81165377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2BB6C8-C0C8-09B1-E675-2E3860F39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B5B863-A331-8C93-C5FD-7674DBC74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E61CEE-EF6C-0F6D-7BC0-3EE209996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514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3DFAE-551D-3E99-9A7D-63E1182641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EEFE50-7054-C311-9FAF-6D78476C2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728DE2-40B2-A2CF-61C9-525EC151A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B38516-2CE8-8E71-1225-4873ABE35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58EDB-DEB4-4384-C892-F0040AE46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72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BEEDF2-B204-6E6E-F83B-76CDE4EC59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6B6962-167B-2A47-2C12-94FD29AD8D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151B28-553B-331E-DE26-E0E272DE3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889D85-5567-3AA2-B40A-650E1A63C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37BD4B-03C9-96D6-598C-0D4741020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695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F51A28-E779-7823-7A32-AB819A757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3BC360-6DDB-0096-738D-CFC4B5F703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B923A3-3798-F57F-4360-552E5F0F2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B697A0-5B5D-8397-CFD5-4053AE62C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1519A-D446-6B79-0CC6-7E7E04D28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17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F8CE9D-F5D2-372F-4A58-0A0BEB97E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6BCF71-F40B-1BE2-22A0-59D86FFEA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31105-6E75-94A4-DE98-85F98BD0B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FBA0A-F741-908F-264E-F732F4FAA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380371-83EF-D383-0FC9-E39ABEF22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981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32590-83B0-49E8-A2C1-362021820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5D9A65-45E0-4B2C-1205-B9F4BB4C09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18675A-DDE6-1380-2C2D-D7B098E259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384EB9-643A-2D1E-A001-BEFC20D11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E2BFA6-9ABD-BFB7-56EB-880C645FD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AF5A10-7F26-7BE2-25AD-5A3C1374A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423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B96BAA-99F7-9CA3-8B8E-41174AD452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661B59-937C-5E92-551E-6383D5921A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7EE8CF-25C0-8676-E877-FDA909582F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FBD73A-7E78-E009-6762-EAAFE0E59D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FE2FF3-4ED2-A8CB-ADD5-78F006C56B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3640E7-5483-2DDF-11FB-F1B94FDEE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941F72-2791-2D07-3F63-BEC438526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4D6CA4-1318-21A4-B941-9923E42E3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66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4F3AA-A3FD-F119-5123-20AB37E36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C01424-2B3B-F80E-AC08-DCFA5A932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881323-457D-79B4-0413-CD189BE04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93691F-ADD0-BDBD-BBF9-F63D01FCF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11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C91684-CB52-D842-2EB8-1A92C36E0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092E92-8CC5-66FF-0903-D013C9486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188A41-FF59-AE5B-82DA-497A7AECA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65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195C0-B900-E9F0-2181-B3267900A5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EFEB0E-2669-3656-15A3-E278EDFFBC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70D65B-180F-E4B1-D229-3A65888379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A05785-EFD5-B281-004F-DA008DD93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A878F1-0E2D-82D4-2481-7C35F97D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A13D1D-8502-C39B-9D75-48DC4DFB4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11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C53FF-41C4-DCB7-6079-0684594216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84B9DF-5FC2-EF62-EB09-C0CCDAA31A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B2BB01-CC3C-1379-BCD9-EFB9EB712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2C4854-5DF2-EC7D-3A02-AB1F5E4B2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BD4B21-0D12-596E-6F3E-A96177818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9CA300-C4A2-BEA0-2334-188143C71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850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CAC497-C12F-F6B4-303B-019FEE0C49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771FDC-7953-ED62-532E-68E7CF2F37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667E96-A3FC-7934-F560-82217BF56C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0CB6D5-2282-7044-8592-50F935A3309D}" type="datetimeFigureOut">
              <a:rPr lang="en-US" smtClean="0"/>
              <a:t>8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65FAD-2259-4F19-A219-FC9D983C75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BF5B15-41DF-EAC0-2671-91DA51DB3F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B280C2-DB11-B644-B180-0FA21B9C5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712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C65CD-7D1E-CB24-BE6E-070650EC63F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upplementa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4D73DF-96D7-F65E-9134-53695A703FD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91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548EDB66-7E9A-28B9-EEFF-C98D128CB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54780" y="640081"/>
            <a:ext cx="4301490" cy="457200"/>
          </a:xfrm>
        </p:spPr>
        <p:txBody>
          <a:bodyPr>
            <a:norm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 </a:t>
            </a:r>
            <a:r>
              <a:rPr lang="en-US" sz="1400" b="1" u="sng">
                <a:latin typeface="Times New Roman" panose="02020603050405020304" pitchFamily="18" charset="0"/>
                <a:cs typeface="Times New Roman" panose="02020603050405020304" pitchFamily="18" charset="0"/>
              </a:rPr>
              <a:t>Reagents for Flow Cytometry</a:t>
            </a:r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9C7933A8-DC4D-1B78-7D2D-D33CFF10B0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2182461"/>
              </p:ext>
            </p:extLst>
          </p:nvPr>
        </p:nvGraphicFramePr>
        <p:xfrm>
          <a:off x="2489893" y="1625600"/>
          <a:ext cx="7132320" cy="333756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188720">
                  <a:extLst>
                    <a:ext uri="{9D8B030D-6E8A-4147-A177-3AD203B41FA5}">
                      <a16:colId xmlns:a16="http://schemas.microsoft.com/office/drawing/2014/main" val="4229332731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4062996640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3139889936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136347392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4051269694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403763476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gen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#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u="sng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I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2830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c Block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314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ml/m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39465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63964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feldin 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sz="1200" b="1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06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ml/m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61109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-F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sz="1200" b="1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13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256234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7173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4-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305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_398528</a:t>
                      </a:r>
                      <a:endParaRPr 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06342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-6.7 (RUO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30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39456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01083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g</a:t>
                      </a:r>
                      <a:endParaRPr lang="en-US" sz="1200" b="1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G1.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-7311-8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183436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90878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1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3-19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-7423-8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46542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26941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et</a:t>
                      </a:r>
                      <a:endParaRPr lang="en-US" sz="1200" b="1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B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-5825-8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_27447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877911"/>
                  </a:ext>
                </a:extLst>
              </a:tr>
            </a:tbl>
          </a:graphicData>
        </a:graphic>
      </p:graphicFrame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7D8B583-0F6E-CF07-35C4-0BF9BC7E1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66CA2-4246-2546-BCDD-E88F9815E29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74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6ABA6-F769-E613-95D0-4950C5702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00302" y="216706"/>
            <a:ext cx="4530858" cy="480695"/>
          </a:xfrm>
        </p:spPr>
        <p:txBody>
          <a:bodyPr>
            <a:norm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A. </a:t>
            </a:r>
            <a:r>
              <a:rPr lang="en-US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Cell Flow Gating Strategy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FBBF517-3B54-5880-7906-4F0D40BC7E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2629" y="4332607"/>
            <a:ext cx="1281737" cy="12596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5F625E4-41C8-77E4-C25A-87EF1FE214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29" y="2849452"/>
            <a:ext cx="1281737" cy="12596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9EF76D9-48AE-AA3E-FB3F-FA0038518E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07498" y="3514896"/>
            <a:ext cx="1281737" cy="125963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D81F05D-EF27-A289-C763-4C00A25A26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60845" y="993133"/>
            <a:ext cx="1281737" cy="125963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6E06DCE-0E51-F119-346D-BB0679C2E0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01761" y="1015570"/>
            <a:ext cx="1281737" cy="125963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6F3EE05-C891-ACAB-D811-625DE7DA44D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42677" y="1016738"/>
            <a:ext cx="1281737" cy="1259638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B5F45BC-BC82-E02B-A4AC-1EA50F7F62FB}"/>
              </a:ext>
            </a:extLst>
          </p:cNvPr>
          <p:cNvCxnSpPr/>
          <p:nvPr/>
        </p:nvCxnSpPr>
        <p:spPr>
          <a:xfrm>
            <a:off x="3542677" y="935776"/>
            <a:ext cx="4599905" cy="0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DDF9BE1-5640-052B-9C50-C8A908086641}"/>
              </a:ext>
            </a:extLst>
          </p:cNvPr>
          <p:cNvCxnSpPr>
            <a:cxnSpLocks/>
          </p:cNvCxnSpPr>
          <p:nvPr/>
        </p:nvCxnSpPr>
        <p:spPr>
          <a:xfrm flipH="1">
            <a:off x="4398529" y="2440646"/>
            <a:ext cx="2669610" cy="399412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3FD23894-0099-73FB-131A-613A7FF28BE5}"/>
              </a:ext>
            </a:extLst>
          </p:cNvPr>
          <p:cNvCxnSpPr/>
          <p:nvPr/>
        </p:nvCxnSpPr>
        <p:spPr>
          <a:xfrm>
            <a:off x="4398529" y="2840058"/>
            <a:ext cx="0" cy="513567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EDA17E7-6415-D2B7-7E6F-49E3D1CCAC99}"/>
              </a:ext>
            </a:extLst>
          </p:cNvPr>
          <p:cNvCxnSpPr>
            <a:cxnSpLocks/>
          </p:cNvCxnSpPr>
          <p:nvPr/>
        </p:nvCxnSpPr>
        <p:spPr>
          <a:xfrm>
            <a:off x="5201761" y="4155616"/>
            <a:ext cx="299058" cy="256784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80999942-B76B-AF3C-C623-DE8EE8CE382A}"/>
              </a:ext>
            </a:extLst>
          </p:cNvPr>
          <p:cNvCxnSpPr>
            <a:cxnSpLocks/>
          </p:cNvCxnSpPr>
          <p:nvPr/>
        </p:nvCxnSpPr>
        <p:spPr>
          <a:xfrm flipV="1">
            <a:off x="5201761" y="3716026"/>
            <a:ext cx="398037" cy="217700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1D6EF056-0D3A-E5C7-3513-8AAB76EABDF6}"/>
              </a:ext>
            </a:extLst>
          </p:cNvPr>
          <p:cNvSpPr txBox="1"/>
          <p:nvPr/>
        </p:nvSpPr>
        <p:spPr>
          <a:xfrm rot="16200000">
            <a:off x="3348795" y="1499841"/>
            <a:ext cx="41870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S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8802DB-0B94-E4BB-B98F-E86E8DE2F87E}"/>
              </a:ext>
            </a:extLst>
          </p:cNvPr>
          <p:cNvSpPr txBox="1"/>
          <p:nvPr/>
        </p:nvSpPr>
        <p:spPr>
          <a:xfrm>
            <a:off x="4063627" y="2181780"/>
            <a:ext cx="42672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E860BF-9308-CC86-6129-E40A890F8486}"/>
              </a:ext>
            </a:extLst>
          </p:cNvPr>
          <p:cNvSpPr txBox="1"/>
          <p:nvPr/>
        </p:nvSpPr>
        <p:spPr>
          <a:xfrm rot="16200000">
            <a:off x="4876883" y="1512486"/>
            <a:ext cx="56297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322D692-0512-6D18-78A4-9DC4657845DF}"/>
              </a:ext>
            </a:extLst>
          </p:cNvPr>
          <p:cNvSpPr txBox="1"/>
          <p:nvPr/>
        </p:nvSpPr>
        <p:spPr>
          <a:xfrm>
            <a:off x="5663850" y="2194425"/>
            <a:ext cx="56938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E7371EC-AD44-FADD-BAFE-C4D243175ED5}"/>
              </a:ext>
            </a:extLst>
          </p:cNvPr>
          <p:cNvSpPr txBox="1"/>
          <p:nvPr/>
        </p:nvSpPr>
        <p:spPr>
          <a:xfrm rot="16200000">
            <a:off x="6524660" y="1461978"/>
            <a:ext cx="56297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E23AFDD-3736-5FF6-EB4E-8C29A942900F}"/>
              </a:ext>
            </a:extLst>
          </p:cNvPr>
          <p:cNvSpPr txBox="1"/>
          <p:nvPr/>
        </p:nvSpPr>
        <p:spPr>
          <a:xfrm>
            <a:off x="7072673" y="2143917"/>
            <a:ext cx="98627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Live/Dea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656E68-0486-8363-E53B-F7D1147F7B3B}"/>
              </a:ext>
            </a:extLst>
          </p:cNvPr>
          <p:cNvSpPr txBox="1"/>
          <p:nvPr/>
        </p:nvSpPr>
        <p:spPr>
          <a:xfrm rot="16200000">
            <a:off x="3549992" y="3947321"/>
            <a:ext cx="71250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549A02A-09FE-92D5-3D23-8D415A5A7271}"/>
              </a:ext>
            </a:extLst>
          </p:cNvPr>
          <p:cNvSpPr txBox="1"/>
          <p:nvPr/>
        </p:nvSpPr>
        <p:spPr>
          <a:xfrm>
            <a:off x="4112787" y="4689584"/>
            <a:ext cx="9606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Live/Dea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00E7EA0-C04E-E18F-9766-A9856E3AF204}"/>
              </a:ext>
            </a:extLst>
          </p:cNvPr>
          <p:cNvSpPr txBox="1"/>
          <p:nvPr/>
        </p:nvSpPr>
        <p:spPr>
          <a:xfrm rot="16200000">
            <a:off x="5491244" y="3296718"/>
            <a:ext cx="71250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6DA3168-4107-3817-14AF-44733918A78E}"/>
              </a:ext>
            </a:extLst>
          </p:cNvPr>
          <p:cNvSpPr txBox="1"/>
          <p:nvPr/>
        </p:nvSpPr>
        <p:spPr>
          <a:xfrm>
            <a:off x="6054039" y="3989821"/>
            <a:ext cx="9606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B0549D5-FD88-072A-C435-F4C6AC0B1FCD}"/>
              </a:ext>
            </a:extLst>
          </p:cNvPr>
          <p:cNvSpPr txBox="1"/>
          <p:nvPr/>
        </p:nvSpPr>
        <p:spPr>
          <a:xfrm rot="16200000">
            <a:off x="5494990" y="4774527"/>
            <a:ext cx="71250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0D3CC2A-C794-B4B4-0519-E326B7FA205F}"/>
              </a:ext>
            </a:extLst>
          </p:cNvPr>
          <p:cNvSpPr txBox="1"/>
          <p:nvPr/>
        </p:nvSpPr>
        <p:spPr>
          <a:xfrm>
            <a:off x="6057785" y="5506267"/>
            <a:ext cx="9606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</a:p>
        </p:txBody>
      </p:sp>
      <p:sp>
        <p:nvSpPr>
          <p:cNvPr id="28" name="Content Placeholder 2">
            <a:extLst>
              <a:ext uri="{FF2B5EF4-FFF2-40B4-BE49-F238E27FC236}">
                <a16:creationId xmlns:a16="http://schemas.microsoft.com/office/drawing/2014/main" id="{DEFB9B3A-949C-D147-A698-0A4E9090826E}"/>
              </a:ext>
            </a:extLst>
          </p:cNvPr>
          <p:cNvSpPr txBox="1">
            <a:spLocks/>
          </p:cNvSpPr>
          <p:nvPr/>
        </p:nvSpPr>
        <p:spPr>
          <a:xfrm>
            <a:off x="2335754" y="5824051"/>
            <a:ext cx="7285074" cy="1102091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Supp. Fig. 1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. 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Flow Cytometry gating for CD4</a:t>
            </a:r>
            <a:r>
              <a:rPr lang="en-US" sz="1200" b="1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+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 and CD8</a:t>
            </a:r>
            <a:r>
              <a:rPr lang="en-US" sz="1200" b="1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+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 T-cells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. The cells were sequentially gated for lymphocyte population, single cells, live cells, and CD45</a:t>
            </a:r>
            <a:r>
              <a:rPr lang="en-US" sz="1200" baseline="30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+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 cells for immunophenotyping of CD4 and CD8 T-cells. </a:t>
            </a:r>
            <a:r>
              <a:rPr lang="en-US" sz="12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Th1 cells are classified as CD4</a:t>
            </a:r>
            <a:r>
              <a:rPr lang="en-US" sz="1200" baseline="300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+</a:t>
            </a:r>
            <a:r>
              <a:rPr lang="en-US" sz="12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IFN</a:t>
            </a:r>
            <a:r>
              <a:rPr lang="en-US" sz="12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Symbol" pitchFamily="2" charset="2"/>
                <a:ea typeface="Arial Unicode MS" panose="020B0604020202020204" pitchFamily="34" charset="-128"/>
              </a:rPr>
              <a:t>g</a:t>
            </a:r>
            <a:r>
              <a:rPr lang="en-US" sz="1200" baseline="300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+</a:t>
            </a:r>
            <a:r>
              <a:rPr lang="en-US" sz="1200" dirty="0">
                <a:solidFill>
                  <a:srgbClr val="000000"/>
                </a:solidFill>
                <a:highlight>
                  <a:srgbClr val="FFFF00"/>
                </a:highlight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 expressing cells.</a:t>
            </a:r>
          </a:p>
        </p:txBody>
      </p:sp>
      <p:sp>
        <p:nvSpPr>
          <p:cNvPr id="18" name="Slide Number Placeholder 17">
            <a:extLst>
              <a:ext uri="{FF2B5EF4-FFF2-40B4-BE49-F238E27FC236}">
                <a16:creationId xmlns:a16="http://schemas.microsoft.com/office/drawing/2014/main" id="{5B80C42C-C3B8-62E8-1996-B491B402C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66CA2-4246-2546-BCDD-E88F9815E29C}" type="slidenum">
              <a:rPr lang="en-US" smtClean="0"/>
              <a:t>3</a:t>
            </a:fld>
            <a:endParaRPr lang="en-US"/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1170E0D7-825A-696E-997C-6E0825B84A73}"/>
              </a:ext>
            </a:extLst>
          </p:cNvPr>
          <p:cNvCxnSpPr>
            <a:cxnSpLocks/>
          </p:cNvCxnSpPr>
          <p:nvPr/>
        </p:nvCxnSpPr>
        <p:spPr>
          <a:xfrm>
            <a:off x="7219537" y="3429000"/>
            <a:ext cx="488468" cy="0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0D3D1BB-3731-9B31-318B-A1500A114A91}"/>
              </a:ext>
            </a:extLst>
          </p:cNvPr>
          <p:cNvSpPr txBox="1"/>
          <p:nvPr/>
        </p:nvSpPr>
        <p:spPr>
          <a:xfrm rot="16200000">
            <a:off x="7471505" y="3317527"/>
            <a:ext cx="9606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AF222B5-7056-563D-29DC-9915A8FCB71E}"/>
              </a:ext>
            </a:extLst>
          </p:cNvPr>
          <p:cNvSpPr txBox="1"/>
          <p:nvPr/>
        </p:nvSpPr>
        <p:spPr>
          <a:xfrm>
            <a:off x="8285808" y="4048130"/>
            <a:ext cx="9606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</a:t>
            </a:r>
            <a:r>
              <a:rPr lang="en-US" sz="1000" b="1" dirty="0" err="1">
                <a:latin typeface="Symbol" pitchFamily="2" charset="2"/>
                <a:cs typeface="Times New Roman" panose="02020603050405020304" pitchFamily="18" charset="0"/>
              </a:rPr>
              <a:t>g</a:t>
            </a:r>
            <a:endParaRPr lang="en-US" sz="1000" b="1" dirty="0">
              <a:latin typeface="Symbol" pitchFamily="2" charset="2"/>
              <a:cs typeface="Times New Roman" panose="02020603050405020304" pitchFamily="18" charset="0"/>
            </a:endParaRP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508CFC7B-309D-A27E-2CA4-31597168E18B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8086456" y="2825990"/>
            <a:ext cx="1280160" cy="1261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41045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BD0570C1-4853-3D76-34D5-45563F726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66CA2-4246-2546-BCDD-E88F9815E29C}" type="slidenum">
              <a:rPr lang="en-US" smtClean="0"/>
              <a:t>4</a:t>
            </a:fld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4BD68B41-87BB-2962-CE61-A6B9F80B0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35242" y="765193"/>
            <a:ext cx="7621708" cy="480695"/>
          </a:xfrm>
        </p:spPr>
        <p:txBody>
          <a:bodyPr>
            <a:norm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D.</a:t>
            </a:r>
            <a:r>
              <a:rPr lang="en-US" sz="14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d</a:t>
            </a:r>
            <a:r>
              <a:rPr lang="en-US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ood Glucose Levels Following Adoptive Transfer of Cel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65D93B-9817-FB70-F5B7-DAD8F89233EF}"/>
              </a:ext>
            </a:extLst>
          </p:cNvPr>
          <p:cNvSpPr txBox="1"/>
          <p:nvPr/>
        </p:nvSpPr>
        <p:spPr>
          <a:xfrm>
            <a:off x="2814700" y="1810334"/>
            <a:ext cx="1141659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</a:p>
        </p:txBody>
      </p:sp>
      <p:sp>
        <p:nvSpPr>
          <p:cNvPr id="12" name="Down Arrow 11">
            <a:extLst>
              <a:ext uri="{FF2B5EF4-FFF2-40B4-BE49-F238E27FC236}">
                <a16:creationId xmlns:a16="http://schemas.microsoft.com/office/drawing/2014/main" id="{5AB5A2AF-02EE-F5C8-1AD2-87D148216194}"/>
              </a:ext>
            </a:extLst>
          </p:cNvPr>
          <p:cNvSpPr/>
          <p:nvPr/>
        </p:nvSpPr>
        <p:spPr>
          <a:xfrm>
            <a:off x="2174925" y="4006661"/>
            <a:ext cx="45719" cy="292608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FF60DD4-F9E5-2320-00B9-13B4D54B7815}"/>
              </a:ext>
            </a:extLst>
          </p:cNvPr>
          <p:cNvSpPr txBox="1"/>
          <p:nvPr/>
        </p:nvSpPr>
        <p:spPr>
          <a:xfrm>
            <a:off x="6989289" y="1810334"/>
            <a:ext cx="173073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b="1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CD8+ T-cells</a:t>
            </a:r>
          </a:p>
        </p:txBody>
      </p:sp>
      <p:sp>
        <p:nvSpPr>
          <p:cNvPr id="13" name="Down Arrow 12">
            <a:extLst>
              <a:ext uri="{FF2B5EF4-FFF2-40B4-BE49-F238E27FC236}">
                <a16:creationId xmlns:a16="http://schemas.microsoft.com/office/drawing/2014/main" id="{6674D91A-DA3E-FEE1-7F4B-11D9EDE5FC34}"/>
              </a:ext>
            </a:extLst>
          </p:cNvPr>
          <p:cNvSpPr/>
          <p:nvPr/>
        </p:nvSpPr>
        <p:spPr>
          <a:xfrm>
            <a:off x="7024014" y="4006661"/>
            <a:ext cx="45719" cy="292608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657FAF6A-6D49-A04B-AE95-17E4350E69FC}"/>
              </a:ext>
            </a:extLst>
          </p:cNvPr>
          <p:cNvSpPr txBox="1">
            <a:spLocks/>
          </p:cNvSpPr>
          <p:nvPr/>
        </p:nvSpPr>
        <p:spPr>
          <a:xfrm>
            <a:off x="2637204" y="5552746"/>
            <a:ext cx="6657521" cy="67302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Supp. Fig. 2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. </a:t>
            </a:r>
            <a:r>
              <a:rPr lang="en-US" sz="12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Weekly blood glucose measurements</a:t>
            </a: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. Data are blood glucose levels in non-diabetic mice.</a:t>
            </a:r>
          </a:p>
          <a:p>
            <a:pPr marL="0" indent="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</a:rPr>
              <a:t>(Arrows indicate the week of cell transfer.)</a:t>
            </a:r>
          </a:p>
          <a:p>
            <a:pPr algn="just">
              <a:lnSpc>
                <a:spcPct val="150000"/>
              </a:lnSpc>
            </a:pPr>
            <a:endParaRPr lang="en-US" sz="12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8B4CB0C-7E9B-BE8C-218D-55D97A2B971F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066020" y="2187931"/>
            <a:ext cx="5888736" cy="272491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E55C8B7-1A81-1CC1-AAB2-6865BA64AD08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148683" y="2368445"/>
            <a:ext cx="4645152" cy="2551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6268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238</Words>
  <Application>Microsoft Macintosh PowerPoint</Application>
  <PresentationFormat>Widescreen</PresentationFormat>
  <Paragraphs>82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Symbol</vt:lpstr>
      <vt:lpstr>Times New Roman</vt:lpstr>
      <vt:lpstr>Office Theme</vt:lpstr>
      <vt:lpstr>supplementary</vt:lpstr>
      <vt:lpstr>Supplemental Table 1. Reagents for Flow Cytometry</vt:lpstr>
      <vt:lpstr>Supplementary Figure 1A. T-Cell Flow Gating Strategy</vt:lpstr>
      <vt:lpstr>Supplementary Figure 2. NOD.scid Blood Glucose Levels Following Adoptive Transfer of Cell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</dc:title>
  <dc:creator>White, Tayleur D</dc:creator>
  <cp:lastModifiedBy>White, Tayleur D</cp:lastModifiedBy>
  <cp:revision>5</cp:revision>
  <cp:lastPrinted>2024-08-07T14:59:11Z</cp:lastPrinted>
  <dcterms:created xsi:type="dcterms:W3CDTF">2024-05-23T13:58:36Z</dcterms:created>
  <dcterms:modified xsi:type="dcterms:W3CDTF">2024-08-07T18:58:32Z</dcterms:modified>
</cp:coreProperties>
</file>